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1" r:id="rId3"/>
    <p:sldId id="27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4F618-474C-490B-8518-6025299D76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1215FF-4B9B-4C80-9392-D33198CC34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C15D32-46F1-49D0-96B8-4AB4C9AA6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02D755-7323-4187-A907-B13E6D32E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7AF18A-12DB-4271-B556-7704B0CF8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925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6D9FFA-066C-47C4-AA62-6607E6DB5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EF288C-0FBA-4F23-9C2F-ABDE5EB720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F92FD2-C6FC-4A3C-8DA1-7C39534AF4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0C695A-9AFA-456A-8C88-DE45DE5F0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2178E3-AF44-42FB-B5E4-1D3F36587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2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5905A1-F979-48B7-B31C-173A7D2CF3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F71862-6E57-4C2F-99A9-CA0AF5B59F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ABE889-802C-4AED-AFB7-D3F68CBD38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39241-4663-43A6-96D9-1C3A53A6A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8C7A4A-5C20-4B03-AA94-D589BA2C6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460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B7ECA-6930-4F85-B309-884C9FC6D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1CC3F9-A8F7-40A0-BEE9-F2787D4B22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1E204C-61B5-4671-BBA2-8B40A22E4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FECC56-14E1-439F-B640-26D6C78DA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8FF540-CFC9-41C5-9402-1C95AC360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7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6F918-3038-456C-BDBD-EED2C1297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EF06D3-3519-43A3-B18B-E01C129332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4E02F-A1D6-48F2-9E3B-66754089C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AB750F-6965-4B8F-B868-B3607AB9E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6FDCEA-2C53-4EFD-8C5F-F19B2C48F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80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AE6C5-2C39-4E5E-831C-72A097014F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59282E-F411-4FF6-9715-4640FECAB8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11F561-29BF-4F49-BCC6-04E1DDF20B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F92C5F-67AD-499B-ACC7-4366B0157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0B40F9-A8A8-457F-86E7-4D9480CB1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E99DD3-C591-4877-B953-952204FD3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95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05A47-645F-4AA5-ABE3-3BFDDF4A4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E83CC3-52CE-4A7D-9C92-40F37EFB13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F08C9F-BFA3-4EFD-B2C7-54ED8A8758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07297E-05A5-422D-9C3C-11138E3D28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3C5101-AE4E-41AE-A25F-2DDC963C8A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A5D527-770B-4F0F-8FCC-803E60FD1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DECFD2-801A-4CE1-BCD0-43862F9C6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D25521-A9E3-4376-A0AA-8ADA91221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565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F49F3-D622-42AA-BE59-4D01097F3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C6E449-7485-4DB8-B7E4-12398BF55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14C206-674B-4D07-8D64-70048F1C9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2E09CF-4EFA-4A69-8A6C-A3731AB4A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970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7843E2-0A8D-46AD-AFA9-A05E2E1FC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809C40-5485-45E1-9491-90E4ED607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07AC19-AF32-4759-B6B3-2BB8D2A26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888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964C4F-ECAB-47CA-B32E-98D5B75BEA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41E29E-2506-4397-A074-93BCE9E55D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CC3D81-800C-4902-A134-D56883B238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04C02D-2B25-420E-ADBE-FDB2B6EC2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88DEEF-D08E-4603-A2DC-130EB9F5F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A331B6-4D86-4098-9F0B-2911B962A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875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119703-69FD-4764-8225-467FCCD89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8A7493-8C85-4299-B6F0-2660AF18FB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183202-ECF3-433C-8B79-D72700B223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859982-185D-46DF-ADBB-298493944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F677BB-3410-41F3-BE7B-8611E59DF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BC1C30-E4B0-4D6F-9692-E8B3FC0EF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878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FF6C61-A902-4DDC-A437-4A4D1DA034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516B02-B5E3-4122-B05F-FD7D05F92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5DCAE8-73F3-4A15-9D59-6995CFF215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03622-33E5-4BD2-90EC-E017AB2A6EDE}" type="datetimeFigureOut">
              <a:rPr lang="en-US" smtClean="0"/>
              <a:t>1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F2EC90-933F-46B3-8EA6-69CB6B520F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6725E3-019F-46B8-A916-6406A8BBB5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F964A-29D4-40CE-B4E9-9B72F6B64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460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64922" y="894296"/>
            <a:ext cx="8268916" cy="4893297"/>
            <a:chOff x="570298" y="966659"/>
            <a:chExt cx="8268916" cy="4893297"/>
          </a:xfrm>
        </p:grpSpPr>
        <p:grpSp>
          <p:nvGrpSpPr>
            <p:cNvPr id="3" name="Group 2"/>
            <p:cNvGrpSpPr/>
            <p:nvPr/>
          </p:nvGrpSpPr>
          <p:grpSpPr>
            <a:xfrm>
              <a:off x="570298" y="966659"/>
              <a:ext cx="8268916" cy="4893297"/>
              <a:chOff x="495677" y="679565"/>
              <a:chExt cx="8268916" cy="4893297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078504" y="679565"/>
                <a:ext cx="7686089" cy="4893297"/>
                <a:chOff x="1078504" y="718754"/>
                <a:chExt cx="7686089" cy="4893297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1078504" y="718754"/>
                  <a:ext cx="7686089" cy="4893297"/>
                  <a:chOff x="1078504" y="718754"/>
                  <a:chExt cx="7686089" cy="4893297"/>
                </a:xfrm>
              </p:grpSpPr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1078504" y="718754"/>
                    <a:ext cx="7686089" cy="4893297"/>
                    <a:chOff x="1078504" y="718754"/>
                    <a:chExt cx="7686089" cy="4893297"/>
                  </a:xfrm>
                </p:grpSpPr>
                <p:grpSp>
                  <p:nvGrpSpPr>
                    <p:cNvPr id="14" name="Group 13"/>
                    <p:cNvGrpSpPr/>
                    <p:nvPr/>
                  </p:nvGrpSpPr>
                  <p:grpSpPr>
                    <a:xfrm>
                      <a:off x="1078504" y="718754"/>
                      <a:ext cx="7686089" cy="4893297"/>
                      <a:chOff x="796833" y="403895"/>
                      <a:chExt cx="8203471" cy="5143988"/>
                    </a:xfrm>
                  </p:grpSpPr>
                  <p:cxnSp>
                    <p:nvCxnSpPr>
                      <p:cNvPr id="16" name="Straight Arrow Connector 15"/>
                      <p:cNvCxnSpPr>
                        <a:stCxn id="20" idx="2"/>
                        <a:endCxn id="21" idx="0"/>
                      </p:cNvCxnSpPr>
                      <p:nvPr/>
                    </p:nvCxnSpPr>
                    <p:spPr>
                      <a:xfrm>
                        <a:off x="4561245" y="4163266"/>
                        <a:ext cx="2292399" cy="809851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7" name="Rounded Rectangle 16"/>
                      <p:cNvSpPr/>
                      <p:nvPr/>
                    </p:nvSpPr>
                    <p:spPr>
                      <a:xfrm>
                        <a:off x="5978435" y="1828801"/>
                        <a:ext cx="1180011" cy="1062308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Domain architecture prediction</a:t>
                        </a:r>
                      </a:p>
                    </p:txBody>
                  </p:sp>
                  <p:sp>
                    <p:nvSpPr>
                      <p:cNvPr id="18" name="Rounded Rectangle 17"/>
                      <p:cNvSpPr/>
                      <p:nvPr/>
                    </p:nvSpPr>
                    <p:spPr>
                      <a:xfrm>
                        <a:off x="1959429" y="1828801"/>
                        <a:ext cx="1180012" cy="1062308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Subcellular localization prediction</a:t>
                        </a:r>
                      </a:p>
                    </p:txBody>
                  </p:sp>
                  <p:sp>
                    <p:nvSpPr>
                      <p:cNvPr id="19" name="Rounded Rectangle 18"/>
                      <p:cNvSpPr/>
                      <p:nvPr/>
                    </p:nvSpPr>
                    <p:spPr>
                      <a:xfrm>
                        <a:off x="3712611" y="2122815"/>
                        <a:ext cx="1750423" cy="574765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Non-redundant sequences</a:t>
                        </a:r>
                      </a:p>
                    </p:txBody>
                  </p:sp>
                  <p:sp>
                    <p:nvSpPr>
                      <p:cNvPr id="20" name="Rounded Rectangle 19"/>
                      <p:cNvSpPr/>
                      <p:nvPr/>
                    </p:nvSpPr>
                    <p:spPr>
                      <a:xfrm>
                        <a:off x="2634609" y="3476595"/>
                        <a:ext cx="3853272" cy="686671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Multiple sequence alignment  (full-length protein sequence alignment/structurally-informed sequence alignment)</a:t>
                        </a:r>
                      </a:p>
                    </p:txBody>
                  </p:sp>
                  <p:sp>
                    <p:nvSpPr>
                      <p:cNvPr id="21" name="Rounded Rectangle 20"/>
                      <p:cNvSpPr/>
                      <p:nvPr/>
                    </p:nvSpPr>
                    <p:spPr>
                      <a:xfrm>
                        <a:off x="5978433" y="4973117"/>
                        <a:ext cx="1750423" cy="574765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Functional divergence test</a:t>
                        </a:r>
                      </a:p>
                    </p:txBody>
                  </p:sp>
                  <p:sp>
                    <p:nvSpPr>
                      <p:cNvPr id="22" name="Rounded Rectangle 21"/>
                      <p:cNvSpPr/>
                      <p:nvPr/>
                    </p:nvSpPr>
                    <p:spPr>
                      <a:xfrm>
                        <a:off x="3683723" y="4973118"/>
                        <a:ext cx="1750423" cy="574765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Phylogenetic analyses</a:t>
                        </a:r>
                      </a:p>
                    </p:txBody>
                  </p:sp>
                  <p:sp>
                    <p:nvSpPr>
                      <p:cNvPr id="23" name="Rounded Rectangle 22"/>
                      <p:cNvSpPr/>
                      <p:nvPr/>
                    </p:nvSpPr>
                    <p:spPr>
                      <a:xfrm>
                        <a:off x="3683722" y="542891"/>
                        <a:ext cx="1750423" cy="593578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Query sequences</a:t>
                        </a:r>
                      </a:p>
                    </p:txBody>
                  </p:sp>
                  <p:sp>
                    <p:nvSpPr>
                      <p:cNvPr id="24" name="Rounded Rectangle 23"/>
                      <p:cNvSpPr/>
                      <p:nvPr/>
                    </p:nvSpPr>
                    <p:spPr>
                      <a:xfrm>
                        <a:off x="1392510" y="403895"/>
                        <a:ext cx="1185086" cy="574765"/>
                      </a:xfrm>
                      <a:prstGeom prst="round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</a:rPr>
                          <a:t>Structures</a:t>
                        </a:r>
                      </a:p>
                    </p:txBody>
                  </p:sp>
                  <p:sp>
                    <p:nvSpPr>
                      <p:cNvPr id="25" name="Pentagon 24"/>
                      <p:cNvSpPr/>
                      <p:nvPr/>
                    </p:nvSpPr>
                    <p:spPr>
                      <a:xfrm flipH="1">
                        <a:off x="7849272" y="1919349"/>
                        <a:ext cx="1149531" cy="287382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NCBI CDD</a:t>
                        </a:r>
                      </a:p>
                    </p:txBody>
                  </p:sp>
                  <p:sp>
                    <p:nvSpPr>
                      <p:cNvPr id="26" name="Pentagon 25"/>
                      <p:cNvSpPr/>
                      <p:nvPr/>
                    </p:nvSpPr>
                    <p:spPr>
                      <a:xfrm flipH="1">
                        <a:off x="7842066" y="2217618"/>
                        <a:ext cx="1149531" cy="287382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HMMER</a:t>
                        </a:r>
                      </a:p>
                    </p:txBody>
                  </p:sp>
                  <p:sp>
                    <p:nvSpPr>
                      <p:cNvPr id="27" name="Pentagon 26"/>
                      <p:cNvSpPr/>
                      <p:nvPr/>
                    </p:nvSpPr>
                    <p:spPr>
                      <a:xfrm flipH="1">
                        <a:off x="7850773" y="2512426"/>
                        <a:ext cx="1149531" cy="287382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PFAM</a:t>
                        </a:r>
                      </a:p>
                    </p:txBody>
                  </p:sp>
                  <p:sp>
                    <p:nvSpPr>
                      <p:cNvPr id="28" name="Pentagon 27"/>
                      <p:cNvSpPr/>
                      <p:nvPr/>
                    </p:nvSpPr>
                    <p:spPr>
                      <a:xfrm flipH="1">
                        <a:off x="4569146" y="1287756"/>
                        <a:ext cx="1149531" cy="287382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NCBI</a:t>
                        </a:r>
                      </a:p>
                    </p:txBody>
                  </p:sp>
                  <p:sp>
                    <p:nvSpPr>
                      <p:cNvPr id="29" name="Pentagon 28"/>
                      <p:cNvSpPr/>
                      <p:nvPr/>
                    </p:nvSpPr>
                    <p:spPr>
                      <a:xfrm flipH="1">
                        <a:off x="4563286" y="1571945"/>
                        <a:ext cx="1149531" cy="287382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 err="1">
                            <a:solidFill>
                              <a:schemeClr val="tx1"/>
                            </a:solidFill>
                          </a:rPr>
                          <a:t>UniProt</a:t>
                        </a:r>
                        <a:endParaRPr lang="en-US" sz="1100" dirty="0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30" name="Pentagon 29"/>
                      <p:cNvSpPr/>
                      <p:nvPr/>
                    </p:nvSpPr>
                    <p:spPr>
                      <a:xfrm flipH="1">
                        <a:off x="6487881" y="3629027"/>
                        <a:ext cx="1149531" cy="287381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MAFFT</a:t>
                        </a:r>
                      </a:p>
                    </p:txBody>
                  </p:sp>
                  <p:sp>
                    <p:nvSpPr>
                      <p:cNvPr id="31" name="Pentagon 30"/>
                      <p:cNvSpPr/>
                      <p:nvPr/>
                    </p:nvSpPr>
                    <p:spPr>
                      <a:xfrm flipH="1">
                        <a:off x="7728856" y="5116813"/>
                        <a:ext cx="1149531" cy="287381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Diverge2.0</a:t>
                        </a:r>
                      </a:p>
                    </p:txBody>
                  </p:sp>
                  <p:sp>
                    <p:nvSpPr>
                      <p:cNvPr id="32" name="Pentagon 31"/>
                      <p:cNvSpPr/>
                      <p:nvPr/>
                    </p:nvSpPr>
                    <p:spPr>
                      <a:xfrm>
                        <a:off x="3461657" y="4207948"/>
                        <a:ext cx="1075504" cy="287381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 err="1">
                            <a:solidFill>
                              <a:schemeClr val="tx1"/>
                            </a:solidFill>
                          </a:rPr>
                          <a:t>PhyML</a:t>
                        </a:r>
                        <a:endParaRPr lang="en-US" sz="1100" dirty="0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33" name="Pentagon 32"/>
                      <p:cNvSpPr/>
                      <p:nvPr/>
                    </p:nvSpPr>
                    <p:spPr>
                      <a:xfrm flipH="1">
                        <a:off x="4567639" y="4540011"/>
                        <a:ext cx="1084153" cy="286871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MrBayes3.2</a:t>
                        </a:r>
                      </a:p>
                    </p:txBody>
                  </p:sp>
                  <p:sp>
                    <p:nvSpPr>
                      <p:cNvPr id="34" name="Pentagon 33"/>
                      <p:cNvSpPr/>
                      <p:nvPr/>
                    </p:nvSpPr>
                    <p:spPr>
                      <a:xfrm>
                        <a:off x="796833" y="2004950"/>
                        <a:ext cx="1149531" cy="316567"/>
                      </a:xfrm>
                      <a:prstGeom prst="homePlat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100" dirty="0" err="1">
                            <a:solidFill>
                              <a:schemeClr val="tx1"/>
                            </a:solidFill>
                          </a:rPr>
                          <a:t>TargetP</a:t>
                        </a:r>
                        <a:endParaRPr lang="en-US" sz="1100" dirty="0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cxnSp>
                    <p:nvCxnSpPr>
                      <p:cNvPr id="35" name="Straight Arrow Connector 34"/>
                      <p:cNvCxnSpPr/>
                      <p:nvPr/>
                    </p:nvCxnSpPr>
                    <p:spPr>
                      <a:xfrm>
                        <a:off x="4558934" y="1150201"/>
                        <a:ext cx="4" cy="961246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6" name="Straight Arrow Connector 35"/>
                      <p:cNvCxnSpPr/>
                      <p:nvPr/>
                    </p:nvCxnSpPr>
                    <p:spPr>
                      <a:xfrm>
                        <a:off x="4550222" y="2713076"/>
                        <a:ext cx="4357" cy="768997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7" name="Straight Arrow Connector 36"/>
                      <p:cNvCxnSpPr>
                        <a:endCxn id="22" idx="0"/>
                      </p:cNvCxnSpPr>
                      <p:nvPr/>
                    </p:nvCxnSpPr>
                    <p:spPr>
                      <a:xfrm>
                        <a:off x="4545865" y="4157509"/>
                        <a:ext cx="13070" cy="815612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8" name="Straight Arrow Connector 37"/>
                      <p:cNvCxnSpPr/>
                      <p:nvPr/>
                    </p:nvCxnSpPr>
                    <p:spPr>
                      <a:xfrm flipH="1">
                        <a:off x="2605476" y="691278"/>
                        <a:ext cx="1073547" cy="982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9" name="Straight Arrow Connector 38"/>
                      <p:cNvCxnSpPr/>
                      <p:nvPr/>
                    </p:nvCxnSpPr>
                    <p:spPr>
                      <a:xfrm flipH="1">
                        <a:off x="3139440" y="2346961"/>
                        <a:ext cx="544282" cy="0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0" name="Left Brace 39"/>
                      <p:cNvSpPr/>
                      <p:nvPr/>
                    </p:nvSpPr>
                    <p:spPr>
                      <a:xfrm>
                        <a:off x="7702732" y="1920240"/>
                        <a:ext cx="117563" cy="879568"/>
                      </a:xfrm>
                      <a:prstGeom prst="leftBrac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600"/>
                      </a:p>
                    </p:txBody>
                  </p:sp>
                  <p:cxnSp>
                    <p:nvCxnSpPr>
                      <p:cNvPr id="41" name="Straight Arrow Connector 40"/>
                      <p:cNvCxnSpPr/>
                      <p:nvPr/>
                    </p:nvCxnSpPr>
                    <p:spPr>
                      <a:xfrm>
                        <a:off x="5440676" y="2346961"/>
                        <a:ext cx="544282" cy="0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" name="Straight Arrow Connector 41"/>
                      <p:cNvCxnSpPr/>
                      <p:nvPr/>
                    </p:nvCxnSpPr>
                    <p:spPr>
                      <a:xfrm>
                        <a:off x="7158446" y="2346961"/>
                        <a:ext cx="544282" cy="0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5" name="Pentagon 14"/>
                    <p:cNvSpPr/>
                    <p:nvPr/>
                  </p:nvSpPr>
                  <p:spPr>
                    <a:xfrm flipH="1">
                      <a:off x="4594658" y="2976634"/>
                      <a:ext cx="1077032" cy="270653"/>
                    </a:xfrm>
                    <a:prstGeom prst="homePlate">
                      <a:avLst/>
                    </a:prstGeom>
                    <a:noFill/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100" dirty="0" err="1">
                          <a:solidFill>
                            <a:schemeClr val="tx1"/>
                          </a:solidFill>
                        </a:rPr>
                        <a:t>BioEdit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sp>
                <p:nvSpPr>
                  <p:cNvPr id="13" name="Pentagon 12"/>
                  <p:cNvSpPr/>
                  <p:nvPr/>
                </p:nvSpPr>
                <p:spPr>
                  <a:xfrm>
                    <a:off x="3597031" y="1552550"/>
                    <a:ext cx="1007673" cy="302376"/>
                  </a:xfrm>
                  <a:prstGeom prst="homePlate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100" dirty="0" err="1">
                        <a:solidFill>
                          <a:schemeClr val="tx1"/>
                        </a:solidFill>
                      </a:rPr>
                      <a:t>Phytozome</a:t>
                    </a:r>
                    <a:endParaRPr lang="en-US" sz="1100" dirty="0">
                      <a:solidFill>
                        <a:schemeClr val="tx1"/>
                      </a:solidFill>
                    </a:endParaRPr>
                  </a:p>
                </p:txBody>
              </p:sp>
            </p:grpSp>
            <p:sp>
              <p:nvSpPr>
                <p:cNvPr id="11" name="Pentagon 10"/>
                <p:cNvSpPr/>
                <p:nvPr/>
              </p:nvSpPr>
              <p:spPr>
                <a:xfrm>
                  <a:off x="1087211" y="2543650"/>
                  <a:ext cx="1077032" cy="312128"/>
                </a:xfrm>
                <a:prstGeom prst="homePlate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err="1">
                      <a:solidFill>
                        <a:schemeClr val="tx1"/>
                      </a:solidFill>
                    </a:rPr>
                    <a:t>UniProt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7" name="Rounded Rectangle 6"/>
              <p:cNvSpPr/>
              <p:nvPr/>
            </p:nvSpPr>
            <p:spPr>
              <a:xfrm>
                <a:off x="1507994" y="1455591"/>
                <a:ext cx="1365739" cy="476532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</a:rPr>
                  <a:t>Structural Superposition</a:t>
                </a:r>
              </a:p>
            </p:txBody>
          </p:sp>
          <p:sp>
            <p:nvSpPr>
              <p:cNvPr id="8" name="Pentagon 7"/>
              <p:cNvSpPr/>
              <p:nvPr/>
            </p:nvSpPr>
            <p:spPr>
              <a:xfrm>
                <a:off x="495677" y="1558729"/>
                <a:ext cx="1007673" cy="257008"/>
              </a:xfrm>
              <a:prstGeom prst="homePlat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</a:rPr>
                  <a:t>FATCAT </a:t>
                </a:r>
              </a:p>
            </p:txBody>
          </p:sp>
          <p:cxnSp>
            <p:nvCxnSpPr>
              <p:cNvPr id="9" name="Straight Arrow Connector 8"/>
              <p:cNvCxnSpPr>
                <a:stCxn id="24" idx="2"/>
                <a:endCxn id="7" idx="0"/>
              </p:cNvCxnSpPr>
              <p:nvPr/>
            </p:nvCxnSpPr>
            <p:spPr>
              <a:xfrm flipH="1">
                <a:off x="2190864" y="1226319"/>
                <a:ext cx="920" cy="22927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Pentagon 3"/>
            <p:cNvSpPr/>
            <p:nvPr/>
          </p:nvSpPr>
          <p:spPr>
            <a:xfrm flipH="1">
              <a:off x="4669279" y="3492052"/>
              <a:ext cx="1077032" cy="270653"/>
            </a:xfrm>
            <a:prstGeom prst="homePlat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</a:rPr>
                <a:t>GUIDANCE 2.0</a:t>
              </a:r>
            </a:p>
          </p:txBody>
        </p:sp>
        <p:sp>
          <p:nvSpPr>
            <p:cNvPr id="5" name="Pentagon 4"/>
            <p:cNvSpPr/>
            <p:nvPr/>
          </p:nvSpPr>
          <p:spPr>
            <a:xfrm>
              <a:off x="3653450" y="4860634"/>
              <a:ext cx="1007673" cy="273376"/>
            </a:xfrm>
            <a:prstGeom prst="homePlat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err="1">
                  <a:solidFill>
                    <a:schemeClr val="tx1"/>
                  </a:solidFill>
                </a:rPr>
                <a:t>IQtree</a:t>
              </a:r>
              <a:endParaRPr lang="en-US" sz="1100" dirty="0">
                <a:solidFill>
                  <a:schemeClr val="tx1"/>
                </a:solidFill>
              </a:endParaRP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F47C491B-5238-4DD5-9792-61D1EAB28BDA}"/>
              </a:ext>
            </a:extLst>
          </p:cNvPr>
          <p:cNvSpPr txBox="1"/>
          <p:nvPr/>
        </p:nvSpPr>
        <p:spPr>
          <a:xfrm>
            <a:off x="9380823" y="6397493"/>
            <a:ext cx="2819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ry Figure S1 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35605917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TextBox 142">
            <a:extLst>
              <a:ext uri="{FF2B5EF4-FFF2-40B4-BE49-F238E27FC236}">
                <a16:creationId xmlns:a16="http://schemas.microsoft.com/office/drawing/2014/main" id="{F47C491B-5238-4DD5-9792-61D1EAB28BDA}"/>
              </a:ext>
            </a:extLst>
          </p:cNvPr>
          <p:cNvSpPr txBox="1"/>
          <p:nvPr/>
        </p:nvSpPr>
        <p:spPr>
          <a:xfrm>
            <a:off x="8137503" y="6206718"/>
            <a:ext cx="2819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ry Figure S2 </a:t>
            </a:r>
            <a:endParaRPr lang="en-IN" b="1" dirty="0"/>
          </a:p>
        </p:txBody>
      </p:sp>
      <p:grpSp>
        <p:nvGrpSpPr>
          <p:cNvPr id="161" name="Group 160"/>
          <p:cNvGrpSpPr/>
          <p:nvPr/>
        </p:nvGrpSpPr>
        <p:grpSpPr>
          <a:xfrm>
            <a:off x="492559" y="863950"/>
            <a:ext cx="10532884" cy="3935760"/>
            <a:chOff x="492559" y="863950"/>
            <a:chExt cx="10532884" cy="3935760"/>
          </a:xfrm>
        </p:grpSpPr>
        <p:grpSp>
          <p:nvGrpSpPr>
            <p:cNvPr id="153" name="Group 152"/>
            <p:cNvGrpSpPr/>
            <p:nvPr/>
          </p:nvGrpSpPr>
          <p:grpSpPr>
            <a:xfrm>
              <a:off x="492559" y="1210423"/>
              <a:ext cx="10486717" cy="3589287"/>
              <a:chOff x="492559" y="1210423"/>
              <a:chExt cx="10486717" cy="3589287"/>
            </a:xfrm>
          </p:grpSpPr>
          <p:pic>
            <p:nvPicPr>
              <p:cNvPr id="144" name="Picture 143"/>
              <p:cNvPicPr preferRelativeResize="0">
                <a:picLocks noChangeAspect="1"/>
              </p:cNvPicPr>
              <p:nvPr/>
            </p:nvPicPr>
            <p:blipFill rotWithShape="1">
              <a:blip r:embed="rId2"/>
              <a:srcRect l="21371" t="46275" r="22495" b="18166"/>
              <a:stretch/>
            </p:blipFill>
            <p:spPr>
              <a:xfrm>
                <a:off x="993460" y="1223579"/>
                <a:ext cx="9985816" cy="3558283"/>
              </a:xfrm>
              <a:prstGeom prst="rect">
                <a:avLst/>
              </a:prstGeom>
            </p:spPr>
          </p:pic>
          <p:grpSp>
            <p:nvGrpSpPr>
              <p:cNvPr id="136" name="Group 135"/>
              <p:cNvGrpSpPr/>
              <p:nvPr/>
            </p:nvGrpSpPr>
            <p:grpSpPr>
              <a:xfrm>
                <a:off x="492559" y="1243320"/>
                <a:ext cx="454734" cy="3538542"/>
                <a:chOff x="1735879" y="1434095"/>
                <a:chExt cx="454734" cy="3538542"/>
              </a:xfrm>
            </p:grpSpPr>
            <p:sp>
              <p:nvSpPr>
                <p:cNvPr id="130" name="Left Brace 129"/>
                <p:cNvSpPr/>
                <p:nvPr/>
              </p:nvSpPr>
              <p:spPr>
                <a:xfrm>
                  <a:off x="2059045" y="1434095"/>
                  <a:ext cx="131568" cy="1322262"/>
                </a:xfrm>
                <a:prstGeom prst="leftBrac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1" name="Left Brace 130"/>
                <p:cNvSpPr/>
                <p:nvPr/>
              </p:nvSpPr>
              <p:spPr>
                <a:xfrm>
                  <a:off x="2059045" y="2803501"/>
                  <a:ext cx="131568" cy="1097280"/>
                </a:xfrm>
                <a:prstGeom prst="leftBrac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" name="Left Brace 131"/>
                <p:cNvSpPr/>
                <p:nvPr/>
              </p:nvSpPr>
              <p:spPr>
                <a:xfrm>
                  <a:off x="2059045" y="3925888"/>
                  <a:ext cx="131568" cy="1005840"/>
                </a:xfrm>
                <a:prstGeom prst="leftBrac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3" name="TextBox 132"/>
                <p:cNvSpPr txBox="1"/>
                <p:nvPr/>
              </p:nvSpPr>
              <p:spPr>
                <a:xfrm rot="16200000">
                  <a:off x="1424351" y="1956726"/>
                  <a:ext cx="90005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nt TGH</a:t>
                  </a:r>
                </a:p>
              </p:txBody>
            </p:sp>
            <p:sp>
              <p:nvSpPr>
                <p:cNvPr id="134" name="TextBox 133"/>
                <p:cNvSpPr txBox="1"/>
                <p:nvPr/>
              </p:nvSpPr>
              <p:spPr>
                <a:xfrm rot="16200000">
                  <a:off x="1308617" y="3213641"/>
                  <a:ext cx="12238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tazoan TGH</a:t>
                  </a:r>
                </a:p>
              </p:txBody>
            </p:sp>
            <p:sp>
              <p:nvSpPr>
                <p:cNvPr id="135" name="TextBox 134"/>
                <p:cNvSpPr txBox="1"/>
                <p:nvPr/>
              </p:nvSpPr>
              <p:spPr>
                <a:xfrm rot="16200000">
                  <a:off x="1410856" y="4324799"/>
                  <a:ext cx="10186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ungal TGH</a:t>
                  </a:r>
                </a:p>
              </p:txBody>
            </p:sp>
          </p:grpSp>
          <p:sp>
            <p:nvSpPr>
              <p:cNvPr id="146" name="5-Point Star 145"/>
              <p:cNvSpPr/>
              <p:nvPr/>
            </p:nvSpPr>
            <p:spPr>
              <a:xfrm>
                <a:off x="4131247" y="1210423"/>
                <a:ext cx="45719" cy="45719"/>
              </a:xfrm>
              <a:prstGeom prst="star5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47" name="5-Point Star 146"/>
              <p:cNvSpPr/>
              <p:nvPr/>
            </p:nvSpPr>
            <p:spPr>
              <a:xfrm>
                <a:off x="5086213" y="1211517"/>
                <a:ext cx="45719" cy="45719"/>
              </a:xfrm>
              <a:prstGeom prst="star5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8" name="5-Point Star 147"/>
              <p:cNvSpPr/>
              <p:nvPr/>
            </p:nvSpPr>
            <p:spPr>
              <a:xfrm>
                <a:off x="10034271" y="1219190"/>
                <a:ext cx="45719" cy="45719"/>
              </a:xfrm>
              <a:prstGeom prst="star5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9" name="5-Point Star 148"/>
              <p:cNvSpPr/>
              <p:nvPr/>
            </p:nvSpPr>
            <p:spPr>
              <a:xfrm>
                <a:off x="10522167" y="1220288"/>
                <a:ext cx="45719" cy="45719"/>
              </a:xfrm>
              <a:prstGeom prst="star5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0" name="5-Point Star 149"/>
              <p:cNvSpPr/>
              <p:nvPr/>
            </p:nvSpPr>
            <p:spPr>
              <a:xfrm>
                <a:off x="6443559" y="4752889"/>
                <a:ext cx="45719" cy="45719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1" name="5-Point Star 150"/>
              <p:cNvSpPr/>
              <p:nvPr/>
            </p:nvSpPr>
            <p:spPr>
              <a:xfrm>
                <a:off x="6260460" y="4753991"/>
                <a:ext cx="45719" cy="45719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54" name="TextBox 153"/>
            <p:cNvSpPr txBox="1"/>
            <p:nvPr/>
          </p:nvSpPr>
          <p:spPr>
            <a:xfrm>
              <a:off x="3999678" y="863950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4954644" y="869289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5631342" y="876630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5977375" y="872717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9681281" y="895577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10572431" y="895577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0762306" y="886810"/>
              <a:ext cx="2631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391324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6110" y="341108"/>
            <a:ext cx="7059780" cy="617578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47C491B-5238-4DD5-9792-61D1EAB28BDA}"/>
              </a:ext>
            </a:extLst>
          </p:cNvPr>
          <p:cNvSpPr txBox="1"/>
          <p:nvPr/>
        </p:nvSpPr>
        <p:spPr>
          <a:xfrm>
            <a:off x="9380823" y="6397493"/>
            <a:ext cx="2819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ry </a:t>
            </a:r>
            <a:r>
              <a:rPr lang="en-US" b="1"/>
              <a:t>Figure S3 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3769138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Widescreen</PresentationFormat>
  <Paragraphs>3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ka Ramji</dc:creator>
  <cp:lastModifiedBy>Taraka Ramji</cp:lastModifiedBy>
  <cp:revision>1</cp:revision>
  <dcterms:created xsi:type="dcterms:W3CDTF">2020-01-30T22:36:47Z</dcterms:created>
  <dcterms:modified xsi:type="dcterms:W3CDTF">2020-01-30T22:37:03Z</dcterms:modified>
</cp:coreProperties>
</file>